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0" r:id="rId2"/>
    <p:sldId id="258" r:id="rId3"/>
    <p:sldId id="261" r:id="rId4"/>
    <p:sldId id="262" r:id="rId5"/>
    <p:sldId id="263" r:id="rId6"/>
    <p:sldId id="259" r:id="rId7"/>
    <p:sldId id="264" r:id="rId8"/>
    <p:sldId id="265" r:id="rId9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94" autoAdjust="0"/>
    <p:restoredTop sz="94660"/>
  </p:normalViewPr>
  <p:slideViewPr>
    <p:cSldViewPr snapToGrid="0">
      <p:cViewPr>
        <p:scale>
          <a:sx n="110" d="100"/>
          <a:sy n="110" d="100"/>
        </p:scale>
        <p:origin x="1032" y="-20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06E1B-1664-4F5A-BF64-054FE218E73D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E3736C-3FC7-4959-9E45-668D5FE6A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945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E3736C-3FC7-4959-9E45-668D5FE6A6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5002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268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819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196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939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878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581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811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894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923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799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482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935372-5D03-4D24-A341-55EB7BB6F172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FDDDDA-7682-4795-B59A-346440258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318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llage of images of a graph&#10;&#10;AI-generated content may be incorrect.">
            <a:extLst>
              <a:ext uri="{FF2B5EF4-FFF2-40B4-BE49-F238E27FC236}">
                <a16:creationId xmlns:a16="http://schemas.microsoft.com/office/drawing/2014/main" id="{15BAF317-F05A-2B18-9EB6-3BB42A8E26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912" y="565020"/>
            <a:ext cx="5687568" cy="559581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34BFB9D-DED7-3B5B-4271-13B260463E93}"/>
              </a:ext>
            </a:extLst>
          </p:cNvPr>
          <p:cNvSpPr txBox="1"/>
          <p:nvPr/>
        </p:nvSpPr>
        <p:spPr>
          <a:xfrm>
            <a:off x="692912" y="6303834"/>
            <a:ext cx="54518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900" b="1"/>
            </a:lvl1pPr>
          </a:lstStyle>
          <a:p>
            <a:r>
              <a:rPr lang="en-US" dirty="0"/>
              <a:t>Supplementary Figure S1: </a:t>
            </a:r>
            <a:r>
              <a:rPr lang="en-US" b="0" dirty="0"/>
              <a:t>Flow cytometer gating used to measure GRP78, xBP1s, ATF4, and CHOP composition in cell culture experiments conducted on MDA-MB-468 cell lines.</a:t>
            </a:r>
          </a:p>
        </p:txBody>
      </p:sp>
    </p:spTree>
    <p:extLst>
      <p:ext uri="{BB962C8B-B14F-4D97-AF65-F5344CB8AC3E}">
        <p14:creationId xmlns:p14="http://schemas.microsoft.com/office/powerpoint/2010/main" val="1702492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ED63A95-1217-CEB2-C771-E1BB1BEA5E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689" y="1002124"/>
            <a:ext cx="5902925" cy="15143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0C1596F-9893-9365-1100-16BF6A04410E}"/>
              </a:ext>
            </a:extLst>
          </p:cNvPr>
          <p:cNvSpPr txBox="1"/>
          <p:nvPr/>
        </p:nvSpPr>
        <p:spPr>
          <a:xfrm>
            <a:off x="347230" y="4820040"/>
            <a:ext cx="65534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2: A) </a:t>
            </a:r>
            <a:r>
              <a:rPr lang="en-US" sz="900" dirty="0"/>
              <a:t>Schematic representation of the experimental timeline for the orthotopic 4T1 lung metastasis study. </a:t>
            </a:r>
            <a:r>
              <a:rPr lang="en-US" sz="900" b="1" dirty="0"/>
              <a:t>B) </a:t>
            </a:r>
            <a:r>
              <a:rPr lang="en-US" sz="900" dirty="0"/>
              <a:t>Schematic representation of the experimental timeline for the orthotopic 4T1 survival study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21199CD-7CA2-5CD6-E6F7-89F10E0380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537" y="3183405"/>
            <a:ext cx="5815584" cy="153430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9894AD3-9A88-A3D2-EEB3-071CF2596F8E}"/>
              </a:ext>
            </a:extLst>
          </p:cNvPr>
          <p:cNvSpPr txBox="1"/>
          <p:nvPr/>
        </p:nvSpPr>
        <p:spPr>
          <a:xfrm>
            <a:off x="399045" y="544536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0995E9-46D0-576E-D925-A5301213F229}"/>
              </a:ext>
            </a:extLst>
          </p:cNvPr>
          <p:cNvSpPr txBox="1"/>
          <p:nvPr/>
        </p:nvSpPr>
        <p:spPr>
          <a:xfrm>
            <a:off x="405141" y="2763480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854975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9F3B8BF-B739-9621-B807-A4FE613BF41E}"/>
              </a:ext>
            </a:extLst>
          </p:cNvPr>
          <p:cNvSpPr txBox="1"/>
          <p:nvPr/>
        </p:nvSpPr>
        <p:spPr>
          <a:xfrm>
            <a:off x="152279" y="533692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pic>
        <p:nvPicPr>
          <p:cNvPr id="4" name="Picture 3" descr="A graph of a number of numbers&#10;&#10;AI-generated content may be incorrect.">
            <a:extLst>
              <a:ext uri="{FF2B5EF4-FFF2-40B4-BE49-F238E27FC236}">
                <a16:creationId xmlns:a16="http://schemas.microsoft.com/office/drawing/2014/main" id="{E443EFF2-BAE9-DA0E-E639-E74ABC53D5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0346" y="587634"/>
            <a:ext cx="2547355" cy="2050575"/>
          </a:xfrm>
          <a:prstGeom prst="rect">
            <a:avLst/>
          </a:prstGeom>
        </p:spPr>
      </p:pic>
      <p:pic>
        <p:nvPicPr>
          <p:cNvPr id="5" name="Picture 4" descr="A graph of a number of hashtags&#10;&#10;AI-generated content may be incorrect.">
            <a:extLst>
              <a:ext uri="{FF2B5EF4-FFF2-40B4-BE49-F238E27FC236}">
                <a16:creationId xmlns:a16="http://schemas.microsoft.com/office/drawing/2014/main" id="{A6FF2EF5-FA44-7D94-8C6E-F1A51F7F1B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56" y="533692"/>
            <a:ext cx="2524055" cy="202709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016029-8510-BE7F-B117-414EB6B025E3}"/>
              </a:ext>
            </a:extLst>
          </p:cNvPr>
          <p:cNvSpPr txBox="1"/>
          <p:nvPr/>
        </p:nvSpPr>
        <p:spPr>
          <a:xfrm>
            <a:off x="3429000" y="544535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B1C3FC-3BC1-841A-127E-C2657A6AC7E2}"/>
              </a:ext>
            </a:extLst>
          </p:cNvPr>
          <p:cNvSpPr txBox="1"/>
          <p:nvPr/>
        </p:nvSpPr>
        <p:spPr>
          <a:xfrm>
            <a:off x="1068383" y="2712243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165187-4CE6-BDCF-8B15-EB94F4400ADA}"/>
              </a:ext>
            </a:extLst>
          </p:cNvPr>
          <p:cNvSpPr txBox="1"/>
          <p:nvPr/>
        </p:nvSpPr>
        <p:spPr>
          <a:xfrm>
            <a:off x="556951" y="5152668"/>
            <a:ext cx="6000750" cy="1338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3: A-B) </a:t>
            </a:r>
            <a:r>
              <a:rPr lang="en-US" sz="900" dirty="0"/>
              <a:t>Time-course analysis of ER stress markers in MDA-MB-468 cells exposed to Asha therapy, </a:t>
            </a:r>
            <a:r>
              <a:rPr lang="en-US" sz="900" dirty="0" err="1"/>
              <a:t>thapsigargin</a:t>
            </a:r>
            <a:r>
              <a:rPr lang="en-US" sz="900" dirty="0"/>
              <a:t> (5 </a:t>
            </a:r>
            <a:r>
              <a:rPr lang="en-US" sz="900" dirty="0" err="1"/>
              <a:t>nM</a:t>
            </a:r>
            <a:r>
              <a:rPr lang="en-US" sz="900" dirty="0"/>
              <a:t>, positive control), or left untreated (control) for up to 96 hours. Levels of CHOP (A) and ATF4 were measured by flow cytometry. Data are presented as mean ± SEM (n=6 per group per time point), normalized to the control group at each time point. Statistical significance was determined using multiple unpaired t-tests comparing each treatment group to the control group at each time point. Significance markers: *, # (p &lt; 0.05); **, ## (p &lt; 0.01); ***, ### (p &lt; 0.001) C) MDA-MB-468 cells exposed to Asha therapy for 96 hours showed no significant reduction in viability compared to untreated controls, as measured by </a:t>
            </a:r>
            <a:r>
              <a:rPr lang="en-US" sz="900" dirty="0" err="1"/>
              <a:t>PrestoBlue</a:t>
            </a:r>
            <a:r>
              <a:rPr lang="en-US" sz="900" dirty="0"/>
              <a:t>™ fluorescence assay (p=0.43, two-sided t-test, n=10 per group). Box plots show median, interquartile range, and full range. Values are background-corrected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F9DE9C7-519B-95C0-7007-9C264CCDED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7918" y="2880777"/>
            <a:ext cx="3162164" cy="2065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440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BF8C73-366E-E09A-53D5-D0669FA55F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98" y="1003465"/>
            <a:ext cx="2981537" cy="20481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A33F436-0E88-CBEA-B2D7-ACD606AF04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765" y="1003465"/>
            <a:ext cx="3102235" cy="20481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6C875A5-7730-EFBB-26B8-C5C1E948E8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095" y="3547929"/>
            <a:ext cx="2824161" cy="204814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3613612-910C-8370-9A4A-89F0BC3F8BFC}"/>
              </a:ext>
            </a:extLst>
          </p:cNvPr>
          <p:cNvSpPr txBox="1"/>
          <p:nvPr/>
        </p:nvSpPr>
        <p:spPr>
          <a:xfrm>
            <a:off x="152279" y="533692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A8140E-0845-15CB-2DBB-00BA8078D15E}"/>
              </a:ext>
            </a:extLst>
          </p:cNvPr>
          <p:cNvSpPr txBox="1"/>
          <p:nvPr/>
        </p:nvSpPr>
        <p:spPr>
          <a:xfrm>
            <a:off x="3429000" y="544535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E06D22-450E-A838-66E7-9A8F572482FB}"/>
              </a:ext>
            </a:extLst>
          </p:cNvPr>
          <p:cNvSpPr txBox="1"/>
          <p:nvPr/>
        </p:nvSpPr>
        <p:spPr>
          <a:xfrm>
            <a:off x="1469618" y="3305055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36E807-AC8E-FF2C-C66D-E2BAE7BE90BF}"/>
              </a:ext>
            </a:extLst>
          </p:cNvPr>
          <p:cNvSpPr txBox="1"/>
          <p:nvPr/>
        </p:nvSpPr>
        <p:spPr>
          <a:xfrm>
            <a:off x="455567" y="6458635"/>
            <a:ext cx="630304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4: A) </a:t>
            </a:r>
            <a:r>
              <a:rPr lang="en-US" sz="900" dirty="0"/>
              <a:t>Longitudinal measurement of primary tumor volume (mm³) in the 4T1 orthotopic model across experimental groups (Control, Asha, anti-PD1, and Combination) in the 28-day metastasis study (n=6/group).  Data represent mean ± SEM. No significant differences in primary tumor volume were observed across groups at the time of surgical resection or study completion.  </a:t>
            </a:r>
            <a:r>
              <a:rPr lang="en-US" sz="900" b="1" dirty="0"/>
              <a:t>B) </a:t>
            </a:r>
            <a:r>
              <a:rPr lang="en-US" sz="900" dirty="0"/>
              <a:t>Body weight measurements over the 28-day treatment period for mice in the metastasis study. Data represent mean ± SEM. The stability of body weight across all groups indicates that Asha therapy and combination regimens were well-tolerated. </a:t>
            </a:r>
            <a:r>
              <a:rPr lang="en-US" sz="900" b="1" dirty="0"/>
              <a:t>C)</a:t>
            </a:r>
            <a:r>
              <a:rPr lang="en-US" sz="900" dirty="0"/>
              <a:t> Body weight measurements over the survival study after primary tumor was resected. Data represent mean ± SEM. The absence of weight loss throughout the monitoring period in both studies indicates that therapy has a good safety profile.</a:t>
            </a:r>
          </a:p>
        </p:txBody>
      </p:sp>
    </p:spTree>
    <p:extLst>
      <p:ext uri="{BB962C8B-B14F-4D97-AF65-F5344CB8AC3E}">
        <p14:creationId xmlns:p14="http://schemas.microsoft.com/office/powerpoint/2010/main" val="15215786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>
            <a:extLst>
              <a:ext uri="{FF2B5EF4-FFF2-40B4-BE49-F238E27FC236}">
                <a16:creationId xmlns:a16="http://schemas.microsoft.com/office/drawing/2014/main" id="{0FFCA0FC-D137-4581-BED9-F9858E5C2B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675" y="1229893"/>
            <a:ext cx="6465417" cy="23134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607524-1B93-3D3D-8149-15C2F69A6AA9}"/>
              </a:ext>
            </a:extLst>
          </p:cNvPr>
          <p:cNvSpPr txBox="1"/>
          <p:nvPr/>
        </p:nvSpPr>
        <p:spPr>
          <a:xfrm>
            <a:off x="569526" y="3797238"/>
            <a:ext cx="60627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latin typeface="Aptos" panose="020B0004020202020204" pitchFamily="34" charset="0"/>
                <a:cs typeface="Arial" panose="020B0604020202020204" pitchFamily="34" charset="0"/>
              </a:rPr>
              <a:t>Supplementary Figure S5</a:t>
            </a:r>
            <a:r>
              <a:rPr lang="en-US" sz="900" dirty="0">
                <a:latin typeface="Aptos" panose="020B0004020202020204" pitchFamily="34" charset="0"/>
                <a:cs typeface="Arial" panose="020B0604020202020204" pitchFamily="34" charset="0"/>
              </a:rPr>
              <a:t>: Leiden cluster annotations validated by CITE-seq surface protein expression (CD45, CD11b, Ly6G, CD81, CD4, Ly6C, F4/80, IA/IE)</a:t>
            </a:r>
          </a:p>
        </p:txBody>
      </p:sp>
    </p:spTree>
    <p:extLst>
      <p:ext uri="{BB962C8B-B14F-4D97-AF65-F5344CB8AC3E}">
        <p14:creationId xmlns:p14="http://schemas.microsoft.com/office/powerpoint/2010/main" val="20912144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CBD34A7-C003-BCDB-FD7C-21A3BEEDCEE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>
            <a:extLst>
              <a:ext uri="{FF2B5EF4-FFF2-40B4-BE49-F238E27FC236}">
                <a16:creationId xmlns:a16="http://schemas.microsoft.com/office/drawing/2014/main" id="{61AD877E-2233-0A52-BA3F-0B9BEA2229E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388" y="489692"/>
            <a:ext cx="6013450" cy="36679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9F6924F-516A-79BE-25C5-1885583B54F2}"/>
              </a:ext>
            </a:extLst>
          </p:cNvPr>
          <p:cNvSpPr txBox="1"/>
          <p:nvPr/>
        </p:nvSpPr>
        <p:spPr>
          <a:xfrm>
            <a:off x="469427" y="4316107"/>
            <a:ext cx="6330234" cy="1338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6: </a:t>
            </a:r>
            <a:r>
              <a:rPr lang="en-US" sz="900" dirty="0"/>
              <a:t>Violin plots illustrate module scores for the seven transcriptional hubs defined by the </a:t>
            </a:r>
            <a:r>
              <a:rPr lang="en-US" sz="900" dirty="0" err="1"/>
              <a:t>NeuMap</a:t>
            </a:r>
            <a:r>
              <a:rPr lang="en-US" sz="900" dirty="0"/>
              <a:t> reference atlas, and the Neutrophil Activation score. </a:t>
            </a:r>
            <a:r>
              <a:rPr lang="en-US" sz="900" dirty="0" err="1"/>
              <a:t>Neumap</a:t>
            </a:r>
            <a:r>
              <a:rPr lang="en-US" sz="900" dirty="0"/>
              <a:t> transcriptional hubs include </a:t>
            </a:r>
            <a:r>
              <a:rPr lang="en-US" sz="900" b="1" dirty="0"/>
              <a:t>A) </a:t>
            </a:r>
            <a:r>
              <a:rPr lang="en-US" sz="900" dirty="0" err="1"/>
              <a:t>PreNeu</a:t>
            </a:r>
            <a:r>
              <a:rPr lang="en-US" sz="900" dirty="0"/>
              <a:t> (progenitor), </a:t>
            </a:r>
            <a:r>
              <a:rPr lang="en-US" sz="900" b="1" dirty="0"/>
              <a:t>B) </a:t>
            </a:r>
            <a:r>
              <a:rPr lang="en-US" sz="900" dirty="0"/>
              <a:t>Immature (early), </a:t>
            </a:r>
            <a:r>
              <a:rPr lang="en-US" sz="900" b="1" dirty="0"/>
              <a:t>C) </a:t>
            </a:r>
            <a:r>
              <a:rPr lang="en-US" sz="900" dirty="0"/>
              <a:t>Immuno-silent (mature), </a:t>
            </a:r>
            <a:r>
              <a:rPr lang="en-US" sz="900" b="1" dirty="0"/>
              <a:t>D) </a:t>
            </a:r>
            <a:r>
              <a:rPr lang="en-US" sz="900" dirty="0"/>
              <a:t>IS-I (suppressive I), </a:t>
            </a:r>
            <a:r>
              <a:rPr lang="en-US" sz="900" b="1" dirty="0"/>
              <a:t>E) </a:t>
            </a:r>
            <a:r>
              <a:rPr lang="en-US" sz="900" dirty="0"/>
              <a:t>IS-II (suppressive II), </a:t>
            </a:r>
            <a:r>
              <a:rPr lang="en-US" sz="900" b="1" dirty="0"/>
              <a:t>F) </a:t>
            </a:r>
            <a:r>
              <a:rPr lang="en-US" sz="900" dirty="0"/>
              <a:t>IFN-responsive (IFN-activated), and </a:t>
            </a:r>
            <a:r>
              <a:rPr lang="en-US" sz="900" b="1" dirty="0"/>
              <a:t>G)</a:t>
            </a:r>
            <a:r>
              <a:rPr lang="en-US" sz="900" dirty="0"/>
              <a:t> Ag (antigen) – presentation. Asha therapy selectively drives a profound enrichment of the IFN-response hub (p &lt; 10</a:t>
            </a:r>
            <a:r>
              <a:rPr lang="en-US" sz="900" baseline="30000" dirty="0"/>
              <a:t>-90</a:t>
            </a:r>
            <a:r>
              <a:rPr lang="en-US" sz="900" dirty="0"/>
              <a:t>, Cohen’s d = 0.49), while changes across all other hubs including immunosuppressive (IS-I, IS-II), immature, and inflammatory states remain negligible (all Cohen’s d &lt; 0.15). </a:t>
            </a:r>
            <a:r>
              <a:rPr lang="en-US" sz="900" b="1" dirty="0"/>
              <a:t>H) </a:t>
            </a:r>
            <a:r>
              <a:rPr lang="en-US" sz="900" dirty="0"/>
              <a:t>Violin plot of the bespoke Neutrophil Activation Score derived from top differentially expressed genes in Asha-treated neutrophils. As expected, this therapy-specific metric reveals a more concentrated and potent shift in the treated population (Cohen’s d = 1.21). Data represent individual cell distributions; internal horizontal lines indicate the median and interquartile range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1EF55A9-9C0C-7A14-B676-C0F0EC721F6E}"/>
              </a:ext>
            </a:extLst>
          </p:cNvPr>
          <p:cNvSpPr txBox="1"/>
          <p:nvPr/>
        </p:nvSpPr>
        <p:spPr>
          <a:xfrm>
            <a:off x="196850" y="329757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09A6DC-A4B0-38D1-1200-B9567393B360}"/>
              </a:ext>
            </a:extLst>
          </p:cNvPr>
          <p:cNvSpPr txBox="1"/>
          <p:nvPr/>
        </p:nvSpPr>
        <p:spPr>
          <a:xfrm>
            <a:off x="2032000" y="329756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D3963F-8D23-4C62-49A4-8C33D2F2A70E}"/>
              </a:ext>
            </a:extLst>
          </p:cNvPr>
          <p:cNvSpPr txBox="1"/>
          <p:nvPr/>
        </p:nvSpPr>
        <p:spPr>
          <a:xfrm>
            <a:off x="3477289" y="331204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636278-3A16-7A79-7DE6-4DB44FC39A8E}"/>
              </a:ext>
            </a:extLst>
          </p:cNvPr>
          <p:cNvSpPr txBox="1"/>
          <p:nvPr/>
        </p:nvSpPr>
        <p:spPr>
          <a:xfrm>
            <a:off x="5077489" y="331204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D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ECCED24-D738-8C35-2DFE-4780AF0C84E5}"/>
              </a:ext>
            </a:extLst>
          </p:cNvPr>
          <p:cNvSpPr txBox="1"/>
          <p:nvPr/>
        </p:nvSpPr>
        <p:spPr>
          <a:xfrm>
            <a:off x="196850" y="2215707"/>
            <a:ext cx="29687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E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CDF404B-A843-59C1-EF55-CA86809D3AB2}"/>
              </a:ext>
            </a:extLst>
          </p:cNvPr>
          <p:cNvSpPr txBox="1"/>
          <p:nvPr/>
        </p:nvSpPr>
        <p:spPr>
          <a:xfrm>
            <a:off x="2032000" y="2215706"/>
            <a:ext cx="29206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F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DF1405-CC06-4E89-9296-923D131354E8}"/>
              </a:ext>
            </a:extLst>
          </p:cNvPr>
          <p:cNvSpPr txBox="1"/>
          <p:nvPr/>
        </p:nvSpPr>
        <p:spPr>
          <a:xfrm>
            <a:off x="3477289" y="2217154"/>
            <a:ext cx="31611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G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63C8D70-4E7F-0D76-82EA-528E14912AEC}"/>
              </a:ext>
            </a:extLst>
          </p:cNvPr>
          <p:cNvSpPr txBox="1"/>
          <p:nvPr/>
        </p:nvSpPr>
        <p:spPr>
          <a:xfrm>
            <a:off x="5077489" y="2217154"/>
            <a:ext cx="31771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H)</a:t>
            </a:r>
          </a:p>
        </p:txBody>
      </p:sp>
    </p:spTree>
    <p:extLst>
      <p:ext uri="{BB962C8B-B14F-4D97-AF65-F5344CB8AC3E}">
        <p14:creationId xmlns:p14="http://schemas.microsoft.com/office/powerpoint/2010/main" val="7542201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3A4EC594-EED8-5B8C-5D25-A06DBE1DF7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3149" y="3421672"/>
            <a:ext cx="3187701" cy="22856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7599BA1A-65DB-3EFE-966F-4860C8CD87A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07" t="6597"/>
          <a:stretch>
            <a:fillRect/>
          </a:stretch>
        </p:blipFill>
        <p:spPr bwMode="auto">
          <a:xfrm>
            <a:off x="-4653" y="431799"/>
            <a:ext cx="3509851" cy="2713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>
            <a:extLst>
              <a:ext uri="{FF2B5EF4-FFF2-40B4-BE49-F238E27FC236}">
                <a16:creationId xmlns:a16="http://schemas.microsoft.com/office/drawing/2014/main" id="{47DFE34A-374E-FE62-52E9-7125B28764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1410" y="126109"/>
            <a:ext cx="3133993" cy="2876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4">
            <a:extLst>
              <a:ext uri="{FF2B5EF4-FFF2-40B4-BE49-F238E27FC236}">
                <a16:creationId xmlns:a16="http://schemas.microsoft.com/office/drawing/2014/main" id="{7F2FE1CE-2993-306B-62DD-E343B172740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8" t="6597" r="33899"/>
          <a:stretch>
            <a:fillRect/>
          </a:stretch>
        </p:blipFill>
        <p:spPr bwMode="auto">
          <a:xfrm>
            <a:off x="-12700" y="3297271"/>
            <a:ext cx="3659076" cy="2713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19D2C4A-9F41-F8F3-0961-7475257631DA}"/>
              </a:ext>
            </a:extLst>
          </p:cNvPr>
          <p:cNvSpPr txBox="1"/>
          <p:nvPr/>
        </p:nvSpPr>
        <p:spPr>
          <a:xfrm>
            <a:off x="-12700" y="126110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C07799C-FBA6-BDF9-2785-E6FB7B4DFF53}"/>
              </a:ext>
            </a:extLst>
          </p:cNvPr>
          <p:cNvSpPr txBox="1"/>
          <p:nvPr/>
        </p:nvSpPr>
        <p:spPr>
          <a:xfrm>
            <a:off x="3587750" y="126109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2C38378-0BA4-5F2D-C8DC-0F2282E51B9D}"/>
              </a:ext>
            </a:extLst>
          </p:cNvPr>
          <p:cNvSpPr txBox="1"/>
          <p:nvPr/>
        </p:nvSpPr>
        <p:spPr>
          <a:xfrm>
            <a:off x="-12700" y="3075157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C0BB7C-2988-C5C7-3213-3F8C7F179480}"/>
              </a:ext>
            </a:extLst>
          </p:cNvPr>
          <p:cNvSpPr txBox="1"/>
          <p:nvPr/>
        </p:nvSpPr>
        <p:spPr>
          <a:xfrm>
            <a:off x="3486150" y="3081507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D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1B50FA-D347-8226-87FB-E922573AFB8E}"/>
              </a:ext>
            </a:extLst>
          </p:cNvPr>
          <p:cNvSpPr txBox="1"/>
          <p:nvPr/>
        </p:nvSpPr>
        <p:spPr>
          <a:xfrm>
            <a:off x="290588" y="6722987"/>
            <a:ext cx="640440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7: Sub-clustering and compositional analysis of the monocyte/macrophage compartment. A) </a:t>
            </a:r>
            <a:r>
              <a:rPr lang="en-US" sz="900" dirty="0"/>
              <a:t>UMAP visualization of myeloid cells following Leiden sub-clustering, which identified 10 distinct transcriptional sub-clusters. </a:t>
            </a:r>
            <a:r>
              <a:rPr lang="en-US" sz="900" b="1" dirty="0"/>
              <a:t>B) </a:t>
            </a:r>
            <a:r>
              <a:rPr lang="en-US" sz="900" dirty="0"/>
              <a:t>Dot plot illustrating the mean expression and fraction of cells expressing lineage-defining markers across the 10 Leiden clusters. These markers were used to aggregate clusters into four functionally defined cell types: C1qa+ Trem2+ </a:t>
            </a:r>
            <a:r>
              <a:rPr lang="en-US" sz="900" dirty="0" err="1"/>
              <a:t>Apoe</a:t>
            </a:r>
            <a:r>
              <a:rPr lang="en-US" sz="900" dirty="0"/>
              <a:t>+ lipid-associated macrophages (clusters 0,2, 5, 6, 9), Ly6c2+ Ccr2+ inflammatory monocytes (clusters 1, 7), Mrc1+ Arg1+ IL4-responsive macrophages (clusters 3, 4), and MHC-II+ macrophages (clusters 8). </a:t>
            </a:r>
            <a:r>
              <a:rPr lang="en-US" sz="900" b="1" dirty="0"/>
              <a:t>C) </a:t>
            </a:r>
            <a:r>
              <a:rPr lang="en-US" sz="900" dirty="0"/>
              <a:t>UMAP projection labeled by the four aggregated transcriptional subsets used for downstream differential expression and pathway analysis. </a:t>
            </a:r>
            <a:r>
              <a:rPr lang="en-US" sz="900" b="1" dirty="0"/>
              <a:t>D) </a:t>
            </a:r>
            <a:r>
              <a:rPr lang="en-US" sz="900" dirty="0"/>
              <a:t>Box plots representing the proportion of identified subsets within the total monocyte/macrophage compartment for Control (c) and Asha-treated (t) groups. Compositional analysis using scCODA confirmed that Asha therapy did not induce significant shifts in the relative proportions of these myeloid populations (p &gt; 0.05).</a:t>
            </a:r>
          </a:p>
        </p:txBody>
      </p:sp>
    </p:spTree>
    <p:extLst>
      <p:ext uri="{BB962C8B-B14F-4D97-AF65-F5344CB8AC3E}">
        <p14:creationId xmlns:p14="http://schemas.microsoft.com/office/powerpoint/2010/main" val="38994292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>
            <a:extLst>
              <a:ext uri="{FF2B5EF4-FFF2-40B4-BE49-F238E27FC236}">
                <a16:creationId xmlns:a16="http://schemas.microsoft.com/office/drawing/2014/main" id="{92DC662F-A1A1-E76A-4678-9672C24D903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1" r="53982"/>
          <a:stretch>
            <a:fillRect/>
          </a:stretch>
        </p:blipFill>
        <p:spPr bwMode="auto">
          <a:xfrm>
            <a:off x="31804" y="336550"/>
            <a:ext cx="3073792" cy="2335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>
            <a:extLst>
              <a:ext uri="{FF2B5EF4-FFF2-40B4-BE49-F238E27FC236}">
                <a16:creationId xmlns:a16="http://schemas.microsoft.com/office/drawing/2014/main" id="{0EBBB983-D0E1-984B-152C-6A8B1BE207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4850" y="74875"/>
            <a:ext cx="3566271" cy="2621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>
            <a:extLst>
              <a:ext uri="{FF2B5EF4-FFF2-40B4-BE49-F238E27FC236}">
                <a16:creationId xmlns:a16="http://schemas.microsoft.com/office/drawing/2014/main" id="{8E246C7A-63AA-CA00-62AE-94312A6F4E8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82" t="6111" b="760"/>
          <a:stretch>
            <a:fillRect/>
          </a:stretch>
        </p:blipFill>
        <p:spPr bwMode="auto">
          <a:xfrm>
            <a:off x="31804" y="2971800"/>
            <a:ext cx="3073792" cy="2335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>
            <a:extLst>
              <a:ext uri="{FF2B5EF4-FFF2-40B4-BE49-F238E27FC236}">
                <a16:creationId xmlns:a16="http://schemas.microsoft.com/office/drawing/2014/main" id="{CA4F902E-0F3C-3BEB-039A-21089248FA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9444" y="3028949"/>
            <a:ext cx="3497081" cy="252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06C41DE-D380-E03D-DAFC-B8DEC07A1906}"/>
              </a:ext>
            </a:extLst>
          </p:cNvPr>
          <p:cNvSpPr txBox="1"/>
          <p:nvPr/>
        </p:nvSpPr>
        <p:spPr>
          <a:xfrm>
            <a:off x="0" y="24510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98894A4-2DD9-300E-69A0-EDA8BDAC0042}"/>
              </a:ext>
            </a:extLst>
          </p:cNvPr>
          <p:cNvSpPr txBox="1"/>
          <p:nvPr/>
        </p:nvSpPr>
        <p:spPr>
          <a:xfrm>
            <a:off x="3213100" y="24509"/>
            <a:ext cx="30328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0EAC83-C0B0-E2AE-B28A-72F46CB3B706}"/>
              </a:ext>
            </a:extLst>
          </p:cNvPr>
          <p:cNvSpPr txBox="1"/>
          <p:nvPr/>
        </p:nvSpPr>
        <p:spPr>
          <a:xfrm>
            <a:off x="0" y="2706857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87325DE-E239-C55C-E550-CDD1914E2EAC}"/>
              </a:ext>
            </a:extLst>
          </p:cNvPr>
          <p:cNvSpPr txBox="1"/>
          <p:nvPr/>
        </p:nvSpPr>
        <p:spPr>
          <a:xfrm>
            <a:off x="3187700" y="2713207"/>
            <a:ext cx="31451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D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831947-A488-0F9E-75E6-F941E3CADFD7}"/>
              </a:ext>
            </a:extLst>
          </p:cNvPr>
          <p:cNvSpPr txBox="1"/>
          <p:nvPr/>
        </p:nvSpPr>
        <p:spPr>
          <a:xfrm>
            <a:off x="226795" y="5733231"/>
            <a:ext cx="640440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8: Sub-clustering and compositional analysis of the T-cell compartment. A) </a:t>
            </a:r>
            <a:r>
              <a:rPr lang="en-US" sz="900" dirty="0"/>
              <a:t>UMAP visualization of T-cells following Leiden sub-clustering, which identified 10 distinct transcriptional sub-clusters. </a:t>
            </a:r>
            <a:r>
              <a:rPr lang="en-US" sz="900" b="1" dirty="0"/>
              <a:t>B) </a:t>
            </a:r>
            <a:r>
              <a:rPr lang="en-US" sz="900" dirty="0"/>
              <a:t>Dot plot illustrating the mean expression and fraction of cells expressing lineage-defining markers across the 10 Leiden clusters. These markers were used to aggregate clusters into five functionally defined cell types: Exhausted CD8+ T-cells (Exhausted_CD8; clusters 1 and 5), regulatory T-cells (Tregs; clusters 0 and 6), CD4+ helper T-cells (CD4_Helper; clusters 2 and 7), CD8+ memory-like (CD8_memory_activated, cluster 4 ),  and gamma-delta T-cells (</a:t>
            </a:r>
            <a:r>
              <a:rPr lang="en-US" sz="900" dirty="0" err="1"/>
              <a:t>Gamma_delta</a:t>
            </a:r>
            <a:r>
              <a:rPr lang="en-US" sz="900" dirty="0"/>
              <a:t>; clusters 3). </a:t>
            </a:r>
            <a:r>
              <a:rPr lang="en-US" sz="900" b="1" dirty="0"/>
              <a:t>C) </a:t>
            </a:r>
            <a:r>
              <a:rPr lang="en-US" sz="900" dirty="0"/>
              <a:t>UMAP projection labeled by the five aggregated transcriptional subsets used for downstream differential expression and pathway analysis. </a:t>
            </a:r>
            <a:r>
              <a:rPr lang="en-US" sz="900" b="1" dirty="0"/>
              <a:t>D) </a:t>
            </a:r>
            <a:r>
              <a:rPr lang="en-US" sz="900" dirty="0"/>
              <a:t>Box plots representing the proportion of identified subsets within the T-cell compartment for Control (c) and Asha-treated (t) groups. Compositional analysis using scCODA confirmed that Asha therapy did not induce significant shifts in the relative proportions of these T-cell populations (p &gt; 0.05).</a:t>
            </a:r>
          </a:p>
        </p:txBody>
      </p:sp>
    </p:spTree>
    <p:extLst>
      <p:ext uri="{BB962C8B-B14F-4D97-AF65-F5344CB8AC3E}">
        <p14:creationId xmlns:p14="http://schemas.microsoft.com/office/powerpoint/2010/main" val="2925364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31</TotalTime>
  <Words>1063</Words>
  <Application>Microsoft Office PowerPoint</Application>
  <PresentationFormat>Letter Paper (8.5x11 in)</PresentationFormat>
  <Paragraphs>33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vek kumar sharma</dc:creator>
  <cp:lastModifiedBy>vivek kumar sharma</cp:lastModifiedBy>
  <cp:revision>65</cp:revision>
  <dcterms:created xsi:type="dcterms:W3CDTF">2025-10-06T18:28:56Z</dcterms:created>
  <dcterms:modified xsi:type="dcterms:W3CDTF">2026-03-20T20:48:53Z</dcterms:modified>
</cp:coreProperties>
</file>